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8" d="100"/>
          <a:sy n="58" d="100"/>
        </p:scale>
        <p:origin x="2491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24235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48371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886575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837366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81530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93485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36754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55686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92477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50801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86180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0/11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92556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8F744FB5-9D41-4021-BFC2-DBDDD51882C0}"/>
              </a:ext>
            </a:extLst>
          </p:cNvPr>
          <p:cNvSpPr txBox="1"/>
          <p:nvPr/>
        </p:nvSpPr>
        <p:spPr>
          <a:xfrm>
            <a:off x="178995" y="8270621"/>
            <a:ext cx="6500005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.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combination identified in the US sub-region of the MDV genome. (A) The recombination of the ATE2539 European and North American strains. (B) The recombination of J-1, 814, GA, ZW2/15, EU-1, HNLC503, DH/1504, LSY, ATE2539, and MD70/13 strains.</a:t>
            </a: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4CB8E328-F989-4FBE-A468-8F04B9912CFC}"/>
              </a:ext>
            </a:extLst>
          </p:cNvPr>
          <p:cNvSpPr txBox="1"/>
          <p:nvPr/>
        </p:nvSpPr>
        <p:spPr>
          <a:xfrm>
            <a:off x="13250" y="635064"/>
            <a:ext cx="5433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58459EF0-3E3D-4932-8E8A-A9C3788EAB00}"/>
              </a:ext>
            </a:extLst>
          </p:cNvPr>
          <p:cNvSpPr txBox="1"/>
          <p:nvPr/>
        </p:nvSpPr>
        <p:spPr>
          <a:xfrm>
            <a:off x="13250" y="2992858"/>
            <a:ext cx="5433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F40FD1F5-CD89-44B6-B94D-B5E9DC323E4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519" y="999263"/>
            <a:ext cx="6296481" cy="1799394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C7B2D81B-4FC6-41A0-AD68-790052007DF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6590" y="3446149"/>
            <a:ext cx="5865876" cy="47155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349834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3</TotalTime>
  <Words>60</Words>
  <Application>Microsoft Office PowerPoint</Application>
  <PresentationFormat>A4 纸张(210x297 毫米)</PresentationFormat>
  <Paragraphs>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Kai Li</dc:creator>
  <cp:lastModifiedBy>likaihvri@163.com</cp:lastModifiedBy>
  <cp:revision>26</cp:revision>
  <dcterms:created xsi:type="dcterms:W3CDTF">2020-10-24T12:47:24Z</dcterms:created>
  <dcterms:modified xsi:type="dcterms:W3CDTF">2020-11-18T01:18:51Z</dcterms:modified>
</cp:coreProperties>
</file>